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AB5CD2-44CB-4446-85D5-3447CE6393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581400"/>
            <a:ext cx="5829120" cy="198612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ctr">
            <a:noAutofit/>
          </a:bodyPr>
          <a:p>
            <a:pPr indent="0" algn="ctr"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6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6EAA5-2434-41B4-BBB6-0C49CA4727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581400"/>
            <a:ext cx="5829120" cy="198612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ctr">
            <a:noAutofit/>
          </a:bodyPr>
          <a:p>
            <a:pPr indent="0" algn="ctr"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6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D967F-0963-4FDB-AE2E-4D4B829B1F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581400"/>
            <a:ext cx="5829120" cy="198612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ctr">
            <a:noAutofit/>
          </a:bodyPr>
          <a:p>
            <a:pPr indent="0" algn="ctr"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6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 fontScale="92000"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 fontScale="92000"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 fontScale="92000"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 fontScale="92000"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 fontScale="92000"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 fontScale="92000"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3374FF-F949-4D67-A42B-0FE4544A4B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581400"/>
            <a:ext cx="5829120" cy="198612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ctr">
            <a:noAutofit/>
          </a:bodyPr>
          <a:p>
            <a:pPr indent="0" algn="ctr"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6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100"/>
              </a:spcBef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6A308E-6AA6-4E12-BC26-D83392621F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581400"/>
            <a:ext cx="5829120" cy="198612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ctr">
            <a:noAutofit/>
          </a:bodyPr>
          <a:p>
            <a:pPr indent="0" algn="ctr"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6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7F74DF-A735-4DF2-B81B-E8DA85A03D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581400"/>
            <a:ext cx="5829120" cy="198612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ctr">
            <a:noAutofit/>
          </a:bodyPr>
          <a:p>
            <a:pPr indent="0" algn="ctr"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6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2300C3-EE6E-44FA-8AC5-BE33B8B032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581400"/>
            <a:ext cx="5829120" cy="198612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ctr">
            <a:noAutofit/>
          </a:bodyPr>
          <a:p>
            <a:pPr indent="0" algn="ctr"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6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DA48CE-3333-4150-893F-0CC8A9E482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100"/>
              </a:spcBef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B3BE2-5887-4369-9800-9809DFBD7A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581400"/>
            <a:ext cx="5829120" cy="198612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ctr">
            <a:noAutofit/>
          </a:bodyPr>
          <a:p>
            <a:pPr indent="0" algn="ctr"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6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EC20E1-A836-47E0-84B2-95484CDE4F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581400"/>
            <a:ext cx="5829120" cy="198612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ctr">
            <a:noAutofit/>
          </a:bodyPr>
          <a:p>
            <a:pPr indent="0" algn="ctr"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6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1DE6B4-9B4C-4A2E-87A1-E8D16E86EA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581400"/>
            <a:ext cx="5829120" cy="198612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ctr">
            <a:noAutofit/>
          </a:bodyPr>
          <a:p>
            <a:pPr indent="0" algn="ctr"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6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/>
          </a:bodyPr>
          <a:p>
            <a:pPr indent="0">
              <a:spcBef>
                <a:spcPts val="1100"/>
              </a:spcBef>
              <a:buNone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5B25B-F1D4-49E5-AA46-B62343A34D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ctr">
            <a:noAutofit/>
          </a:bodyPr>
          <a:p>
            <a:pPr indent="0" algn="ctr">
              <a:buNone/>
              <a:tabLst>
                <a:tab algn="l" pos="0"/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r>
              <a:rPr b="0" lang="en-US" sz="61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6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rmAutofit fontScale="74000"/>
          </a:bodyPr>
          <a:p>
            <a:pPr marL="351360" indent="-351360">
              <a:spcBef>
                <a:spcPts val="1100"/>
              </a:spcBef>
              <a:buClr>
                <a:srgbClr val="000000"/>
              </a:buClr>
              <a:buFont typeface="Arial"/>
              <a:buChar char="•"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  <a:p>
            <a:pPr lvl="1" marL="762120" indent="-292320">
              <a:spcBef>
                <a:spcPts val="1100"/>
              </a:spcBef>
              <a:buClr>
                <a:srgbClr val="000000"/>
              </a:buClr>
              <a:buFont typeface="Arial"/>
              <a:buChar char="–"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  <a:p>
            <a:pPr lvl="2" marL="1173240" indent="-233280">
              <a:spcBef>
                <a:spcPts val="1100"/>
              </a:spcBef>
              <a:buClr>
                <a:srgbClr val="000000"/>
              </a:buClr>
              <a:buFont typeface="Arial"/>
              <a:buChar char="•"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  <a:p>
            <a:pPr lvl="3" marL="1643400" indent="-233280">
              <a:spcBef>
                <a:spcPts val="1100"/>
              </a:spcBef>
              <a:buClr>
                <a:srgbClr val="000000"/>
              </a:buClr>
              <a:buFont typeface="Arial"/>
              <a:buChar char="–"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  <a:p>
            <a:pPr lvl="4" marL="2114640" indent="-234720">
              <a:spcBef>
                <a:spcPts val="1100"/>
              </a:spcBef>
              <a:buClr>
                <a:srgbClr val="000000"/>
              </a:buClr>
              <a:buFont typeface="Arial"/>
              <a:buChar char="»"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  <a:p>
            <a:pPr lvl="5" marL="2114640" indent="-234720">
              <a:spcBef>
                <a:spcPts val="1100"/>
              </a:spcBef>
              <a:buClr>
                <a:srgbClr val="000000"/>
              </a:buClr>
              <a:buFont typeface="Arial"/>
              <a:buChar char="»"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  <a:p>
            <a:pPr lvl="6" marL="2114640" indent="-234720">
              <a:spcBef>
                <a:spcPts val="1100"/>
              </a:spcBef>
              <a:buClr>
                <a:srgbClr val="000000"/>
              </a:buClr>
              <a:buFont typeface="Arial"/>
              <a:buChar char="»"/>
              <a:tabLst>
                <a:tab algn="l" pos="1270080"/>
                <a:tab algn="l" pos="2540160"/>
                <a:tab algn="l" pos="3809880"/>
                <a:tab algn="l" pos="5079960"/>
                <a:tab algn="l" pos="6350040"/>
                <a:tab algn="l" pos="7620120"/>
                <a:tab algn="l" pos="8889840"/>
                <a:tab algn="l" pos="101599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127080" rIns="127080" tIns="63360" bIns="6336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92AE04-749B-4EF5-AA9C-7B3E9BB94949}" type="slidenum">
              <a:rPr b="0" lang="en-US" sz="1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73" descr="maize9 to maize_v2"/>
          <p:cNvPicPr/>
          <p:nvPr/>
        </p:nvPicPr>
        <p:blipFill>
          <a:blip r:embed="rId1"/>
          <a:srcRect l="31288" t="24770" r="31170" b="11241"/>
          <a:stretch/>
        </p:blipFill>
        <p:spPr>
          <a:xfrm>
            <a:off x="1168560" y="1092240"/>
            <a:ext cx="1846080" cy="59608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67" descr=""/>
          <p:cNvPicPr/>
          <p:nvPr/>
        </p:nvPicPr>
        <p:blipFill>
          <a:blip r:embed="rId2"/>
          <a:stretch/>
        </p:blipFill>
        <p:spPr>
          <a:xfrm>
            <a:off x="3833640" y="838080"/>
            <a:ext cx="1957680" cy="30481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74" descr=""/>
          <p:cNvPicPr/>
          <p:nvPr/>
        </p:nvPicPr>
        <p:blipFill>
          <a:blip r:embed="rId3"/>
          <a:stretch/>
        </p:blipFill>
        <p:spPr>
          <a:xfrm>
            <a:off x="3798720" y="4568760"/>
            <a:ext cx="2005200" cy="2997360"/>
          </a:xfrm>
          <a:prstGeom prst="rect">
            <a:avLst/>
          </a:prstGeom>
          <a:ln w="0">
            <a:noFill/>
          </a:ln>
        </p:spPr>
      </p:pic>
      <p:sp>
        <p:nvSpPr>
          <p:cNvPr id="44" name="Rectangle 6"/>
          <p:cNvSpPr/>
          <p:nvPr/>
        </p:nvSpPr>
        <p:spPr>
          <a:xfrm>
            <a:off x="918360" y="465300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7"/>
          <p:cNvSpPr/>
          <p:nvPr/>
        </p:nvSpPr>
        <p:spPr>
          <a:xfrm>
            <a:off x="918360" y="573876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0"/>
          <p:cNvSpPr/>
          <p:nvPr/>
        </p:nvSpPr>
        <p:spPr>
          <a:xfrm>
            <a:off x="918360" y="625644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3"/>
          <p:cNvSpPr/>
          <p:nvPr/>
        </p:nvSpPr>
        <p:spPr>
          <a:xfrm>
            <a:off x="924840" y="120348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5"/>
          <p:cNvSpPr/>
          <p:nvPr/>
        </p:nvSpPr>
        <p:spPr>
          <a:xfrm>
            <a:off x="921600" y="167652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7"/>
          <p:cNvSpPr/>
          <p:nvPr/>
        </p:nvSpPr>
        <p:spPr>
          <a:xfrm>
            <a:off x="924840" y="214956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20"/>
          <p:cNvSpPr/>
          <p:nvPr/>
        </p:nvSpPr>
        <p:spPr>
          <a:xfrm>
            <a:off x="924840" y="302580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24"/>
          <p:cNvSpPr/>
          <p:nvPr/>
        </p:nvSpPr>
        <p:spPr>
          <a:xfrm>
            <a:off x="2367720" y="168120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.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5"/>
          <p:cNvSpPr/>
          <p:nvPr/>
        </p:nvSpPr>
        <p:spPr>
          <a:xfrm>
            <a:off x="2370960" y="226548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.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6"/>
          <p:cNvSpPr/>
          <p:nvPr/>
        </p:nvSpPr>
        <p:spPr>
          <a:xfrm>
            <a:off x="2367720" y="490392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7"/>
          <p:cNvSpPr/>
          <p:nvPr/>
        </p:nvSpPr>
        <p:spPr>
          <a:xfrm>
            <a:off x="2370960" y="564048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8"/>
          <p:cNvSpPr/>
          <p:nvPr/>
        </p:nvSpPr>
        <p:spPr>
          <a:xfrm>
            <a:off x="2374200" y="588024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31"/>
          <p:cNvSpPr/>
          <p:nvPr/>
        </p:nvSpPr>
        <p:spPr>
          <a:xfrm>
            <a:off x="2374200" y="623880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34"/>
          <p:cNvSpPr/>
          <p:nvPr/>
        </p:nvSpPr>
        <p:spPr>
          <a:xfrm>
            <a:off x="2367720" y="660384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3"/>
          <p:cNvSpPr/>
          <p:nvPr/>
        </p:nvSpPr>
        <p:spPr>
          <a:xfrm>
            <a:off x="3529800" y="5102280"/>
            <a:ext cx="287280" cy="166680"/>
          </a:xfrm>
          <a:prstGeom prst="rect">
            <a:avLst/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8"/>
          <p:cNvSpPr/>
          <p:nvPr/>
        </p:nvSpPr>
        <p:spPr>
          <a:xfrm>
            <a:off x="3533040" y="7051680"/>
            <a:ext cx="287280" cy="166680"/>
          </a:xfrm>
          <a:prstGeom prst="rect">
            <a:avLst/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2"/>
          <p:cNvSpPr/>
          <p:nvPr/>
        </p:nvSpPr>
        <p:spPr>
          <a:xfrm>
            <a:off x="5815800" y="4870440"/>
            <a:ext cx="287280" cy="166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3"/>
          <p:cNvSpPr/>
          <p:nvPr/>
        </p:nvSpPr>
        <p:spPr>
          <a:xfrm>
            <a:off x="5819040" y="5437080"/>
            <a:ext cx="287280" cy="166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6"/>
          <p:cNvSpPr/>
          <p:nvPr/>
        </p:nvSpPr>
        <p:spPr>
          <a:xfrm>
            <a:off x="5819040" y="6288120"/>
            <a:ext cx="287280" cy="166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8"/>
          <p:cNvSpPr/>
          <p:nvPr/>
        </p:nvSpPr>
        <p:spPr>
          <a:xfrm>
            <a:off x="5815800" y="7083360"/>
            <a:ext cx="287280" cy="166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6"/>
          <p:cNvSpPr/>
          <p:nvPr/>
        </p:nvSpPr>
        <p:spPr>
          <a:xfrm>
            <a:off x="3525840" y="6118200"/>
            <a:ext cx="287280" cy="166680"/>
          </a:xfrm>
          <a:prstGeom prst="rect">
            <a:avLst/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65"/>
          <p:cNvSpPr/>
          <p:nvPr/>
        </p:nvSpPr>
        <p:spPr>
          <a:xfrm>
            <a:off x="708120" y="304920"/>
            <a:ext cx="217440" cy="25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67"/>
          <p:cNvSpPr/>
          <p:nvPr/>
        </p:nvSpPr>
        <p:spPr>
          <a:xfrm>
            <a:off x="3201120" y="304920"/>
            <a:ext cx="217440" cy="25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68"/>
          <p:cNvSpPr/>
          <p:nvPr/>
        </p:nvSpPr>
        <p:spPr>
          <a:xfrm>
            <a:off x="3201120" y="4114800"/>
            <a:ext cx="217440" cy="25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47"/>
          <p:cNvSpPr/>
          <p:nvPr/>
        </p:nvSpPr>
        <p:spPr>
          <a:xfrm>
            <a:off x="965160" y="919080"/>
            <a:ext cx="631800" cy="197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ize 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47"/>
          <p:cNvSpPr/>
          <p:nvPr/>
        </p:nvSpPr>
        <p:spPr>
          <a:xfrm>
            <a:off x="2374920" y="1379520"/>
            <a:ext cx="639720" cy="197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ize 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47"/>
          <p:cNvSpPr/>
          <p:nvPr/>
        </p:nvSpPr>
        <p:spPr>
          <a:xfrm>
            <a:off x="2425680" y="4667400"/>
            <a:ext cx="622440" cy="197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iz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47"/>
          <p:cNvSpPr/>
          <p:nvPr/>
        </p:nvSpPr>
        <p:spPr>
          <a:xfrm>
            <a:off x="2575080" y="5410080"/>
            <a:ext cx="428400" cy="169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spAutoFit/>
          </a:bodyPr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47"/>
          <p:cNvSpPr/>
          <p:nvPr/>
        </p:nvSpPr>
        <p:spPr>
          <a:xfrm>
            <a:off x="2522520" y="2090880"/>
            <a:ext cx="449280" cy="168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spAutoFit/>
          </a:bodyPr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5"/>
          <p:cNvSpPr/>
          <p:nvPr/>
        </p:nvSpPr>
        <p:spPr>
          <a:xfrm flipH="1">
            <a:off x="5815800" y="2235240"/>
            <a:ext cx="287280" cy="166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.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8"/>
          <p:cNvSpPr/>
          <p:nvPr/>
        </p:nvSpPr>
        <p:spPr>
          <a:xfrm flipH="1">
            <a:off x="3529800" y="2235240"/>
            <a:ext cx="287280" cy="166680"/>
          </a:xfrm>
          <a:prstGeom prst="rect">
            <a:avLst/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8"/>
          <p:cNvSpPr/>
          <p:nvPr/>
        </p:nvSpPr>
        <p:spPr>
          <a:xfrm flipH="1">
            <a:off x="1066680" y="5613480"/>
            <a:ext cx="152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9"/>
          <p:cNvSpPr/>
          <p:nvPr/>
        </p:nvSpPr>
        <p:spPr>
          <a:xfrm flipH="1">
            <a:off x="1066320" y="6026040"/>
            <a:ext cx="149400" cy="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11"/>
          <p:cNvSpPr/>
          <p:nvPr/>
        </p:nvSpPr>
        <p:spPr>
          <a:xfrm flipH="1">
            <a:off x="1072800" y="6477120"/>
            <a:ext cx="142920" cy="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14"/>
          <p:cNvSpPr/>
          <p:nvPr/>
        </p:nvSpPr>
        <p:spPr>
          <a:xfrm flipH="1">
            <a:off x="1071720" y="1528920"/>
            <a:ext cx="142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16"/>
          <p:cNvSpPr/>
          <p:nvPr/>
        </p:nvSpPr>
        <p:spPr>
          <a:xfrm flipH="1">
            <a:off x="1069560" y="1974960"/>
            <a:ext cx="1429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18"/>
          <p:cNvSpPr/>
          <p:nvPr/>
        </p:nvSpPr>
        <p:spPr>
          <a:xfrm flipH="1">
            <a:off x="1066320" y="2482920"/>
            <a:ext cx="14940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0520" bIns="-2052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21"/>
          <p:cNvSpPr/>
          <p:nvPr/>
        </p:nvSpPr>
        <p:spPr>
          <a:xfrm flipH="1">
            <a:off x="1066680" y="3962520"/>
            <a:ext cx="152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29"/>
          <p:cNvSpPr/>
          <p:nvPr/>
        </p:nvSpPr>
        <p:spPr>
          <a:xfrm flipH="1">
            <a:off x="2369880" y="6121440"/>
            <a:ext cx="2840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30"/>
          <p:cNvSpPr/>
          <p:nvPr/>
        </p:nvSpPr>
        <p:spPr>
          <a:xfrm flipH="1" flipV="1">
            <a:off x="2362320" y="5820840"/>
            <a:ext cx="28872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0160" bIns="-201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32"/>
          <p:cNvSpPr/>
          <p:nvPr/>
        </p:nvSpPr>
        <p:spPr>
          <a:xfrm flipH="1" flipV="1">
            <a:off x="2362320" y="6544800"/>
            <a:ext cx="28872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0160" bIns="-201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33"/>
          <p:cNvSpPr/>
          <p:nvPr/>
        </p:nvSpPr>
        <p:spPr>
          <a:xfrm flipH="1" flipV="1">
            <a:off x="2366640" y="5618160"/>
            <a:ext cx="2840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0520" bIns="-2052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14"/>
          <p:cNvSpPr/>
          <p:nvPr/>
        </p:nvSpPr>
        <p:spPr>
          <a:xfrm flipH="1" flipV="1">
            <a:off x="3741480" y="4703400"/>
            <a:ext cx="2667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17280" bIns="-1728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15"/>
          <p:cNvSpPr/>
          <p:nvPr/>
        </p:nvSpPr>
        <p:spPr>
          <a:xfrm flipH="1">
            <a:off x="3750840" y="5654520"/>
            <a:ext cx="257400" cy="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17"/>
          <p:cNvSpPr/>
          <p:nvPr/>
        </p:nvSpPr>
        <p:spPr>
          <a:xfrm flipH="1">
            <a:off x="3750840" y="6737400"/>
            <a:ext cx="257400" cy="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24"/>
          <p:cNvSpPr/>
          <p:nvPr/>
        </p:nvSpPr>
        <p:spPr>
          <a:xfrm flipH="1">
            <a:off x="5605560" y="5864400"/>
            <a:ext cx="255600" cy="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25"/>
          <p:cNvSpPr/>
          <p:nvPr/>
        </p:nvSpPr>
        <p:spPr>
          <a:xfrm flipH="1">
            <a:off x="5605560" y="5157720"/>
            <a:ext cx="255600" cy="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27"/>
          <p:cNvSpPr/>
          <p:nvPr/>
        </p:nvSpPr>
        <p:spPr>
          <a:xfrm flipH="1">
            <a:off x="5605560" y="6859440"/>
            <a:ext cx="255600" cy="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29"/>
          <p:cNvSpPr/>
          <p:nvPr/>
        </p:nvSpPr>
        <p:spPr>
          <a:xfrm flipH="1">
            <a:off x="5605560" y="4730760"/>
            <a:ext cx="264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eft Bracket 64"/>
          <p:cNvSpPr/>
          <p:nvPr/>
        </p:nvSpPr>
        <p:spPr>
          <a:xfrm>
            <a:off x="3200400" y="868320"/>
            <a:ext cx="177840" cy="2933640"/>
          </a:xfrm>
          <a:custGeom>
            <a:avLst/>
            <a:gdLst>
              <a:gd name="textAreaLeft" fmla="*/ 52200 w 177840"/>
              <a:gd name="textAreaRight" fmla="*/ 177840 w 177840"/>
              <a:gd name="textAreaTop" fmla="*/ 7200 h 2933640"/>
              <a:gd name="textAreaBottom" fmla="*/ 2926440 h 2933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10"/>
                </a:cubicBezTo>
                <a:lnTo>
                  <a:pt x="0" y="21490"/>
                </a:lnTo>
                <a:cubicBezTo>
                  <a:pt x="0" y="21545"/>
                  <a:pt x="108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traight Connector 32"/>
          <p:cNvSpPr/>
          <p:nvPr/>
        </p:nvSpPr>
        <p:spPr>
          <a:xfrm>
            <a:off x="3008160" y="1728720"/>
            <a:ext cx="192240" cy="606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eft Bracket 64"/>
          <p:cNvSpPr/>
          <p:nvPr/>
        </p:nvSpPr>
        <p:spPr>
          <a:xfrm>
            <a:off x="3200400" y="4581360"/>
            <a:ext cx="179280" cy="2971800"/>
          </a:xfrm>
          <a:custGeom>
            <a:avLst/>
            <a:gdLst>
              <a:gd name="textAreaLeft" fmla="*/ 52560 w 179280"/>
              <a:gd name="textAreaRight" fmla="*/ 179640 w 179280"/>
              <a:gd name="textAreaTop" fmla="*/ 7200 h 2971800"/>
              <a:gd name="textAreaBottom" fmla="*/ 2964600 h 2971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5"/>
                  <a:pt x="0" y="109"/>
                </a:cubicBezTo>
                <a:lnTo>
                  <a:pt x="0" y="21491"/>
                </a:lnTo>
                <a:cubicBezTo>
                  <a:pt x="0" y="21546"/>
                  <a:pt x="108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Straight Connector 36"/>
          <p:cNvSpPr/>
          <p:nvPr/>
        </p:nvSpPr>
        <p:spPr>
          <a:xfrm flipV="1">
            <a:off x="2971800" y="6067440"/>
            <a:ext cx="228600" cy="123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eft Bracket 64"/>
          <p:cNvSpPr/>
          <p:nvPr/>
        </p:nvSpPr>
        <p:spPr>
          <a:xfrm flipH="1">
            <a:off x="2865600" y="1405080"/>
            <a:ext cx="142560" cy="647640"/>
          </a:xfrm>
          <a:custGeom>
            <a:avLst/>
            <a:gdLst>
              <a:gd name="textAreaLeft" fmla="*/ 42120 w 142560"/>
              <a:gd name="textAreaRight" fmla="*/ 143280 w 142560"/>
              <a:gd name="textAreaTop" fmla="*/ 5760 h 647640"/>
              <a:gd name="textAreaBottom" fmla="*/ 641880 h 647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199"/>
                  <a:pt x="0" y="398"/>
                </a:cubicBezTo>
                <a:lnTo>
                  <a:pt x="0" y="21202"/>
                </a:lnTo>
                <a:cubicBezTo>
                  <a:pt x="0" y="21401"/>
                  <a:pt x="108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eft Bracket 64"/>
          <p:cNvSpPr/>
          <p:nvPr/>
        </p:nvSpPr>
        <p:spPr>
          <a:xfrm flipH="1">
            <a:off x="2828160" y="5448240"/>
            <a:ext cx="142920" cy="1486080"/>
          </a:xfrm>
          <a:custGeom>
            <a:avLst/>
            <a:gdLst>
              <a:gd name="textAreaLeft" fmla="*/ 42120 w 142920"/>
              <a:gd name="textAreaRight" fmla="*/ 143280 w 142920"/>
              <a:gd name="textAreaTop" fmla="*/ 5760 h 1486080"/>
              <a:gd name="textAreaBottom" fmla="*/ 1480320 h 14860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65"/>
          <p:cNvSpPr/>
          <p:nvPr/>
        </p:nvSpPr>
        <p:spPr>
          <a:xfrm>
            <a:off x="1066680" y="6515280"/>
            <a:ext cx="142920" cy="304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12"/>
          <p:cNvSpPr/>
          <p:nvPr/>
        </p:nvSpPr>
        <p:spPr>
          <a:xfrm>
            <a:off x="924840" y="657072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47"/>
          <p:cNvSpPr/>
          <p:nvPr/>
        </p:nvSpPr>
        <p:spPr>
          <a:xfrm>
            <a:off x="3881520" y="660240"/>
            <a:ext cx="631800" cy="197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ize 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47"/>
          <p:cNvSpPr/>
          <p:nvPr/>
        </p:nvSpPr>
        <p:spPr>
          <a:xfrm>
            <a:off x="3886200" y="4465800"/>
            <a:ext cx="631800" cy="197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ize 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47"/>
          <p:cNvSpPr/>
          <p:nvPr/>
        </p:nvSpPr>
        <p:spPr>
          <a:xfrm>
            <a:off x="5135400" y="660240"/>
            <a:ext cx="579600" cy="197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ize 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47"/>
          <p:cNvSpPr/>
          <p:nvPr/>
        </p:nvSpPr>
        <p:spPr>
          <a:xfrm>
            <a:off x="5105520" y="4465800"/>
            <a:ext cx="622080" cy="197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4280" rIns="44280" tIns="22320" bIns="2232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iz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66"/>
          <p:cNvSpPr/>
          <p:nvPr/>
        </p:nvSpPr>
        <p:spPr>
          <a:xfrm>
            <a:off x="2178000" y="8655120"/>
            <a:ext cx="2622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1040"/>
                <a:tab algn="l" pos="1162080"/>
                <a:tab algn="l" pos="1743120"/>
                <a:tab algn="l" pos="2324160"/>
                <a:tab algn="l" pos="2905200"/>
                <a:tab algn="l" pos="3486240"/>
                <a:tab algn="l" pos="4067280"/>
                <a:tab algn="l" pos="4648320"/>
                <a:tab algn="l" pos="5229360"/>
                <a:tab algn="l" pos="5810400"/>
                <a:tab algn="l" pos="6391440"/>
                <a:tab algn="l" pos="6972480"/>
                <a:tab algn="l" pos="7553160"/>
                <a:tab algn="l" pos="8134200"/>
                <a:tab algn="l" pos="8715240"/>
                <a:tab algn="l" pos="9296280"/>
                <a:tab algn="l" pos="9877320"/>
                <a:tab algn="l" pos="10458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2. Figueroa and Bas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22"/>
          <p:cNvSpPr/>
          <p:nvPr/>
        </p:nvSpPr>
        <p:spPr>
          <a:xfrm>
            <a:off x="5875200" y="4637160"/>
            <a:ext cx="28728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ub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22"/>
          <p:cNvSpPr/>
          <p:nvPr/>
        </p:nvSpPr>
        <p:spPr>
          <a:xfrm>
            <a:off x="5871600" y="5070600"/>
            <a:ext cx="68364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umc157(chn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22"/>
          <p:cNvSpPr/>
          <p:nvPr/>
        </p:nvSpPr>
        <p:spPr>
          <a:xfrm>
            <a:off x="5874120" y="5770440"/>
            <a:ext cx="39564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umc7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22"/>
          <p:cNvSpPr/>
          <p:nvPr/>
        </p:nvSpPr>
        <p:spPr>
          <a:xfrm>
            <a:off x="5870520" y="6770520"/>
            <a:ext cx="57096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sg45(ptk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22"/>
          <p:cNvSpPr/>
          <p:nvPr/>
        </p:nvSpPr>
        <p:spPr>
          <a:xfrm>
            <a:off x="619200" y="1449360"/>
            <a:ext cx="45216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umc1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22"/>
          <p:cNvSpPr/>
          <p:nvPr/>
        </p:nvSpPr>
        <p:spPr>
          <a:xfrm>
            <a:off x="811800" y="1893960"/>
            <a:ext cx="25380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z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22"/>
          <p:cNvSpPr/>
          <p:nvPr/>
        </p:nvSpPr>
        <p:spPr>
          <a:xfrm>
            <a:off x="795600" y="2397240"/>
            <a:ext cx="27072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wx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22"/>
          <p:cNvSpPr/>
          <p:nvPr/>
        </p:nvSpPr>
        <p:spPr>
          <a:xfrm>
            <a:off x="647280" y="3879720"/>
            <a:ext cx="41832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su14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22"/>
          <p:cNvSpPr/>
          <p:nvPr/>
        </p:nvSpPr>
        <p:spPr>
          <a:xfrm>
            <a:off x="664200" y="5537160"/>
            <a:ext cx="39564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umc9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22"/>
          <p:cNvSpPr/>
          <p:nvPr/>
        </p:nvSpPr>
        <p:spPr>
          <a:xfrm>
            <a:off x="647280" y="5937120"/>
            <a:ext cx="41832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su63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22"/>
          <p:cNvSpPr/>
          <p:nvPr/>
        </p:nvSpPr>
        <p:spPr>
          <a:xfrm>
            <a:off x="703440" y="6394320"/>
            <a:ext cx="36648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sg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22"/>
          <p:cNvSpPr/>
          <p:nvPr/>
        </p:nvSpPr>
        <p:spPr>
          <a:xfrm>
            <a:off x="2073960" y="5537160"/>
            <a:ext cx="28728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ub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22"/>
          <p:cNvSpPr/>
          <p:nvPr/>
        </p:nvSpPr>
        <p:spPr>
          <a:xfrm>
            <a:off x="1674360" y="5740560"/>
            <a:ext cx="68364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umc157(chn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22"/>
          <p:cNvSpPr/>
          <p:nvPr/>
        </p:nvSpPr>
        <p:spPr>
          <a:xfrm>
            <a:off x="1970640" y="6040440"/>
            <a:ext cx="39564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umc7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22"/>
          <p:cNvSpPr/>
          <p:nvPr/>
        </p:nvSpPr>
        <p:spPr>
          <a:xfrm>
            <a:off x="1787760" y="6464160"/>
            <a:ext cx="57096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sg45(ptk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22"/>
          <p:cNvSpPr/>
          <p:nvPr/>
        </p:nvSpPr>
        <p:spPr>
          <a:xfrm>
            <a:off x="3335760" y="4621320"/>
            <a:ext cx="39564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umc9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22"/>
          <p:cNvSpPr/>
          <p:nvPr/>
        </p:nvSpPr>
        <p:spPr>
          <a:xfrm>
            <a:off x="3334680" y="5572080"/>
            <a:ext cx="41832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su63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22"/>
          <p:cNvSpPr/>
          <p:nvPr/>
        </p:nvSpPr>
        <p:spPr>
          <a:xfrm>
            <a:off x="3388320" y="6656400"/>
            <a:ext cx="36648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sg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11"/>
          <p:cNvSpPr/>
          <p:nvPr/>
        </p:nvSpPr>
        <p:spPr>
          <a:xfrm flipH="1">
            <a:off x="1069560" y="6827760"/>
            <a:ext cx="1429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4280" rIns="44280" tIns="-21960" bIns="-2196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22"/>
          <p:cNvSpPr/>
          <p:nvPr/>
        </p:nvSpPr>
        <p:spPr>
          <a:xfrm>
            <a:off x="650520" y="6746760"/>
            <a:ext cx="418320" cy="166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su54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12"/>
          <p:cNvSpPr/>
          <p:nvPr/>
        </p:nvSpPr>
        <p:spPr>
          <a:xfrm>
            <a:off x="918360" y="6878520"/>
            <a:ext cx="287280" cy="16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4280" rIns="44280" tIns="22320" bIns="22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.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27"/>
          <p:cNvSpPr/>
          <p:nvPr/>
        </p:nvSpPr>
        <p:spPr>
          <a:xfrm>
            <a:off x="3849120" y="299880"/>
            <a:ext cx="1942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uplicate Region 9-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92"/>
          <p:cNvSpPr/>
          <p:nvPr/>
        </p:nvSpPr>
        <p:spPr>
          <a:xfrm>
            <a:off x="3849120" y="4132440"/>
            <a:ext cx="1942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uplicate Region 9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6T23:50:54Z</dcterms:created>
  <dc:creator>Debbie M. Figueroa</dc:creator>
  <dc:description/>
  <dc:language>en-US</dc:language>
  <cp:lastModifiedBy>Debbie Figueroa</cp:lastModifiedBy>
  <cp:lastPrinted>2011-09-12T14:58:53Z</cp:lastPrinted>
  <dcterms:modified xsi:type="dcterms:W3CDTF">2012-03-26T23:47:43Z</dcterms:modified>
  <cp:revision>156</cp:revision>
  <dc:subject/>
  <dc:title>PowerPoint Presentation</dc:title>
</cp:coreProperties>
</file>